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112" d="100"/>
          <a:sy n="112" d="100"/>
        </p:scale>
        <p:origin x="78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5400ED8-B0D5-4162-BBE5-E48BF9C9F3AA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DC04310D-B400-4855-849E-631D0F6BC940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5D1CA39-9103-45C7-BE89-EC8294AB8C3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65B8D1-2779-4BDE-9B87-430F33C088D7}" type="datetimeFigureOut">
              <a:rPr lang="en-GB" smtClean="0"/>
              <a:t>05/03/2024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5920E9A-164C-4064-B36F-97C729EC0BF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1204726-F230-47E9-8929-1FF4C8FEE35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9BA2B8-4891-4A3B-894B-7F7D121718E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6724842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185E91C-F671-4700-8776-32A79F51F74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F4487CED-1F1B-49EB-8420-35A04878471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62B04B8-6E6B-4D95-B19D-58554036D57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65B8D1-2779-4BDE-9B87-430F33C088D7}" type="datetimeFigureOut">
              <a:rPr lang="en-GB" smtClean="0"/>
              <a:t>05/03/2024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FAED4CA-369F-4352-A34D-3FCB78A4446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238F072-43DF-4E51-AE9E-4560B8EC182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9BA2B8-4891-4A3B-894B-7F7D121718E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1443587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C67B3B1B-401F-49E3-B4BC-8C240F6BAF6D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E15B0323-69D9-4A3E-98FF-CC7DF006544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2E5A14D-B42E-4F40-AA18-35105AB83B5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65B8D1-2779-4BDE-9B87-430F33C088D7}" type="datetimeFigureOut">
              <a:rPr lang="en-GB" smtClean="0"/>
              <a:t>05/03/2024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1B24EC2-9399-4AC3-867B-46F1E9D52E9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FA4BF6D-677D-4486-8BAE-490293496B6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9BA2B8-4891-4A3B-894B-7F7D121718E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2086693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1ADB506-6321-4B07-A979-3424B45FBB1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7EF4380-7DB9-478F-BF83-70F1BE91C2E5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F0E41D3-0E78-476A-9D95-48A2984B2C7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65B8D1-2779-4BDE-9B87-430F33C088D7}" type="datetimeFigureOut">
              <a:rPr lang="en-GB" smtClean="0"/>
              <a:t>05/03/2024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1E09651-3B7F-4DB2-BDB4-3577407B677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BE9ABF2-B5A5-4126-8B7E-1D89F09579B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9BA2B8-4891-4A3B-894B-7F7D121718E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9445758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CF5BC19-9424-4680-97D0-A97F00DBE46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842F320E-6FA1-45E2-92DC-676382AD4F8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19394FB-5A41-4BB2-A88C-58E2B10E076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65B8D1-2779-4BDE-9B87-430F33C088D7}" type="datetimeFigureOut">
              <a:rPr lang="en-GB" smtClean="0"/>
              <a:t>05/03/2024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CCFB291-9D9C-41AC-AE32-0F00E636F56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993BC73-E900-4D6A-9521-1D24E32DAA8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9BA2B8-4891-4A3B-894B-7F7D121718E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6675848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BEC6E1F-B7A8-4BEC-99AE-5583C4DF5BA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156EC4D-1A20-4D85-B26E-57D235655368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9428856B-90FC-4DAB-9326-78C35250E8C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2A982D21-064F-46FF-8843-C0F3D568634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65B8D1-2779-4BDE-9B87-430F33C088D7}" type="datetimeFigureOut">
              <a:rPr lang="en-GB" smtClean="0"/>
              <a:t>05/03/2024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2581CEDD-4B2C-4C83-B79D-6E9B543519A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1A5B853D-E880-4B20-BD44-CFCD2EA3FFE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9BA2B8-4891-4A3B-894B-7F7D121718E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48471709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6DF94E1-7DFA-4F51-8418-33128A69624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BC4FF8DC-7516-48C7-9F4C-2398A866515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29589FD5-0C03-4067-AACC-C09AA800C7C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7F88D91B-3063-4819-96CD-23BCAC87A0D6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F4F935ED-FB54-434C-8DBA-854707C4F084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2F0E84C0-DFFC-40FF-9508-FDE415BCD3A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65B8D1-2779-4BDE-9B87-430F33C088D7}" type="datetimeFigureOut">
              <a:rPr lang="en-GB" smtClean="0"/>
              <a:t>05/03/2024</a:t>
            </a:fld>
            <a:endParaRPr lang="en-GB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B1D494B9-16DB-4336-AA63-B935F481DC4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AF106532-C372-405A-B113-F8FA6461288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9BA2B8-4891-4A3B-894B-7F7D121718E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2943934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C15407E-834A-49D2-BCAB-93B01C79DC4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A049FF37-BB42-4445-972E-8AD4DD25E28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65B8D1-2779-4BDE-9B87-430F33C088D7}" type="datetimeFigureOut">
              <a:rPr lang="en-GB" smtClean="0"/>
              <a:t>05/03/2024</a:t>
            </a:fld>
            <a:endParaRPr lang="en-GB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C2DD3466-3C3A-4C0A-A67C-B0DD0150539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D94532F8-7232-4B4F-A226-F532990B0FB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9BA2B8-4891-4A3B-894B-7F7D121718E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2951087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82673B72-F3C2-432F-BB20-820B6314EB2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65B8D1-2779-4BDE-9B87-430F33C088D7}" type="datetimeFigureOut">
              <a:rPr lang="en-GB" smtClean="0"/>
              <a:t>05/03/2024</a:t>
            </a:fld>
            <a:endParaRPr lang="en-GB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97EA801B-05DB-4166-B69C-2835A67B2F1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830C7039-F579-486B-A308-FE9306C79C1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9BA2B8-4891-4A3B-894B-7F7D121718E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8397257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90B6150-9AE8-4F44-B26F-3AE672EF9EC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1D53852-C60D-477C-BD33-A9C2CD38F998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DA5492D4-132A-45F5-B63D-9C78B762431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007EBBE3-C66C-4B11-8601-46AEBC9A8D0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65B8D1-2779-4BDE-9B87-430F33C088D7}" type="datetimeFigureOut">
              <a:rPr lang="en-GB" smtClean="0"/>
              <a:t>05/03/2024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2F3B89C-0C55-4A0E-B7C6-A71D528B6C6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BAC3A4DF-BFC9-461E-95FD-E2EB0D9F12C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9BA2B8-4891-4A3B-894B-7F7D121718E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48738794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D7EE962-995A-49D8-AD22-29816BB5753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EEF08642-9C36-40FC-9CEE-3D8538E61FF6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2C998EB8-28AC-4F71-83B5-27D69D70B8E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3CD27A26-0612-451C-9D85-869247A494D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65B8D1-2779-4BDE-9B87-430F33C088D7}" type="datetimeFigureOut">
              <a:rPr lang="en-GB" smtClean="0"/>
              <a:t>05/03/2024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FFE60522-E0F0-4F47-84CE-A67D8954270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47D0D16-6E40-4EA6-9F29-BD8B5B879A8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9BA2B8-4891-4A3B-894B-7F7D121718E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8218399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0AA33AB6-F6AB-4552-9EC6-BD349E414AE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5025AD30-5AE2-44E0-8FA4-F28E202CEC2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06A62BA-F1D1-468D-BD66-A70CFE035EA1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565B8D1-2779-4BDE-9B87-430F33C088D7}" type="datetimeFigureOut">
              <a:rPr lang="en-GB" smtClean="0"/>
              <a:t>05/03/2024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A3C2342-0DEE-45C5-AAAB-E1BE91020077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898CD8A-C669-41D7-AC58-7D9095046E0E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D9BA2B8-4891-4A3B-894B-7F7D121718E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44042447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2">
            <a:extLst>
              <a:ext uri="{FF2B5EF4-FFF2-40B4-BE49-F238E27FC236}">
                <a16:creationId xmlns:a16="http://schemas.microsoft.com/office/drawing/2014/main" id="{695E1359-9EC6-4486-9601-26EDAFD8AC97}"/>
              </a:ext>
            </a:extLst>
          </p:cNvPr>
          <p:cNvSpPr>
            <a:spLocks noChangeArrowheads="1"/>
          </p:cNvSpPr>
          <p:nvPr/>
        </p:nvSpPr>
        <p:spPr bwMode="auto">
          <a:xfrm>
            <a:off x="0" y="-326"/>
            <a:ext cx="21547861" cy="55399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Additional file 1. Initial programme theory </a:t>
            </a:r>
            <a:endParaRPr kumimoji="0" lang="en-GB" altLang="en-US" sz="8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en-GB" altLang="en-US" sz="18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pic>
        <p:nvPicPr>
          <p:cNvPr id="1025" name="Picture 1">
            <a:extLst>
              <a:ext uri="{FF2B5EF4-FFF2-40B4-BE49-F238E27FC236}">
                <a16:creationId xmlns:a16="http://schemas.microsoft.com/office/drawing/2014/main" id="{869CDB49-73A9-4948-99ED-B0B8C2FD7EE2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819" r="4610" b="2502"/>
          <a:stretch>
            <a:fillRect/>
          </a:stretch>
        </p:blipFill>
        <p:spPr bwMode="auto">
          <a:xfrm>
            <a:off x="845573" y="276673"/>
            <a:ext cx="10117394" cy="6127673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5" name="Rectangle 3">
            <a:extLst>
              <a:ext uri="{FF2B5EF4-FFF2-40B4-BE49-F238E27FC236}">
                <a16:creationId xmlns:a16="http://schemas.microsoft.com/office/drawing/2014/main" id="{4A097E15-62FB-481C-BC5E-5649A9866892}"/>
              </a:ext>
            </a:extLst>
          </p:cNvPr>
          <p:cNvSpPr>
            <a:spLocks noChangeArrowheads="1"/>
          </p:cNvSpPr>
          <p:nvPr/>
        </p:nvSpPr>
        <p:spPr bwMode="auto">
          <a:xfrm>
            <a:off x="113071" y="6350494"/>
            <a:ext cx="11965858" cy="46166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This is not a realist programme theory. This is our initial theory of how services would operate and key service delivery processes and was refined into a more refined realist programme theory</a:t>
            </a:r>
            <a:r>
              <a:rPr lang="en-GB" altLang="en-US" sz="1200" dirty="0">
                <a:latin typeface="Calibri" panose="020F0502020204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 us</a:t>
            </a:r>
            <a:r>
              <a: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ing the interview data </a:t>
            </a:r>
            <a:r>
              <a:rPr kumimoji="0" lang="en-GB" altLang="en-US" sz="12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we collected </a:t>
            </a:r>
            <a:r>
              <a: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(see Figures 1-3 in the main manuscript).</a:t>
            </a:r>
            <a:endParaRPr kumimoji="0" lang="en-GB" altLang="en-US" sz="18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40994594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76</TotalTime>
  <Words>55</Words>
  <Application>Microsoft Office PowerPoint</Application>
  <PresentationFormat>Widescreen</PresentationFormat>
  <Paragraphs>2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Fisher, Louise</dc:creator>
  <cp:lastModifiedBy>Fisher, Louise</cp:lastModifiedBy>
  <cp:revision>3</cp:revision>
  <dcterms:created xsi:type="dcterms:W3CDTF">2024-02-22T15:11:02Z</dcterms:created>
  <dcterms:modified xsi:type="dcterms:W3CDTF">2024-03-05T18:13:43Z</dcterms:modified>
</cp:coreProperties>
</file>